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9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9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803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73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0722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2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942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69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752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25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292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11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999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51A8A-5A5B-44A9-9A0A-AF0813404B74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92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図 29">
            <a:extLst>
              <a:ext uri="{FF2B5EF4-FFF2-40B4-BE49-F238E27FC236}">
                <a16:creationId xmlns:a16="http://schemas.microsoft.com/office/drawing/2014/main" id="{07D20791-F7A8-4A1D-B08A-2B69365F75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1490" y="332709"/>
            <a:ext cx="4163487" cy="2880221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0F08D567-CEB9-476A-A9E3-53643024517B}"/>
              </a:ext>
            </a:extLst>
          </p:cNvPr>
          <p:cNvSpPr/>
          <p:nvPr/>
        </p:nvSpPr>
        <p:spPr>
          <a:xfrm rot="16200000">
            <a:off x="-245325" y="1461171"/>
            <a:ext cx="2037315" cy="2536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3A2C4AF-5E66-4028-9272-12162AB235B1}"/>
              </a:ext>
            </a:extLst>
          </p:cNvPr>
          <p:cNvSpPr txBox="1"/>
          <p:nvPr/>
        </p:nvSpPr>
        <p:spPr>
          <a:xfrm>
            <a:off x="1304013" y="72288"/>
            <a:ext cx="3393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reatment method and survival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77EB9D1-AEBA-4304-A945-8CADAF75157C}"/>
              </a:ext>
            </a:extLst>
          </p:cNvPr>
          <p:cNvSpPr txBox="1"/>
          <p:nvPr/>
        </p:nvSpPr>
        <p:spPr>
          <a:xfrm>
            <a:off x="1816613" y="2181177"/>
            <a:ext cx="1906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nvasive treatment (n=51)</a:t>
            </a: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7E5AF76C-6DEB-45C9-B906-B26E2601B922}"/>
              </a:ext>
            </a:extLst>
          </p:cNvPr>
          <p:cNvCxnSpPr>
            <a:cxnSpLocks/>
          </p:cNvCxnSpPr>
          <p:nvPr/>
        </p:nvCxnSpPr>
        <p:spPr>
          <a:xfrm>
            <a:off x="1373502" y="2326024"/>
            <a:ext cx="3986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611D20CF-126E-4F49-802D-225AE71E5A0D}"/>
              </a:ext>
            </a:extLst>
          </p:cNvPr>
          <p:cNvCxnSpPr>
            <a:cxnSpLocks/>
          </p:cNvCxnSpPr>
          <p:nvPr/>
        </p:nvCxnSpPr>
        <p:spPr>
          <a:xfrm>
            <a:off x="1373502" y="2474593"/>
            <a:ext cx="398661" cy="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A472E65-E962-456D-824A-C883E045E1E4}"/>
              </a:ext>
            </a:extLst>
          </p:cNvPr>
          <p:cNvSpPr txBox="1"/>
          <p:nvPr/>
        </p:nvSpPr>
        <p:spPr>
          <a:xfrm>
            <a:off x="1816612" y="2344873"/>
            <a:ext cx="2061967" cy="2512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hemotherapy only (n=29)</a:t>
            </a: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44087DD5-6B4F-4A21-B806-231B5C39F1B9}"/>
              </a:ext>
            </a:extLst>
          </p:cNvPr>
          <p:cNvCxnSpPr>
            <a:cxnSpLocks/>
          </p:cNvCxnSpPr>
          <p:nvPr/>
        </p:nvCxnSpPr>
        <p:spPr>
          <a:xfrm>
            <a:off x="1373502" y="2623161"/>
            <a:ext cx="398661" cy="0"/>
          </a:xfrm>
          <a:prstGeom prst="line">
            <a:avLst/>
          </a:prstGeom>
          <a:ln w="12700">
            <a:solidFill>
              <a:schemeClr val="accent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7157230-7992-438D-B2D3-A82FBDA9592C}"/>
              </a:ext>
            </a:extLst>
          </p:cNvPr>
          <p:cNvSpPr txBox="1"/>
          <p:nvPr/>
        </p:nvSpPr>
        <p:spPr>
          <a:xfrm>
            <a:off x="1816612" y="2500728"/>
            <a:ext cx="2878797" cy="2512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one (n=11)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13591EF-5C24-45BC-B962-FD44477D3A4F}"/>
              </a:ext>
            </a:extLst>
          </p:cNvPr>
          <p:cNvSpPr/>
          <p:nvPr/>
        </p:nvSpPr>
        <p:spPr>
          <a:xfrm>
            <a:off x="1693646" y="2961662"/>
            <a:ext cx="2535884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 after recurrence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14DB53F-0045-4822-AFFA-46CB3BFAD0CC}"/>
              </a:ext>
            </a:extLst>
          </p:cNvPr>
          <p:cNvSpPr txBox="1"/>
          <p:nvPr/>
        </p:nvSpPr>
        <p:spPr>
          <a:xfrm>
            <a:off x="3402281" y="429919"/>
            <a:ext cx="1392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&lt;0.0001 *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5D485FF-3B38-46D6-9164-77C3E62BC62C}"/>
              </a:ext>
            </a:extLst>
          </p:cNvPr>
          <p:cNvSpPr txBox="1"/>
          <p:nvPr/>
        </p:nvSpPr>
        <p:spPr>
          <a:xfrm>
            <a:off x="310838" y="1648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CF07E6A-01D5-4436-B462-4C99083CE587}"/>
              </a:ext>
            </a:extLst>
          </p:cNvPr>
          <p:cNvSpPr txBox="1"/>
          <p:nvPr/>
        </p:nvSpPr>
        <p:spPr>
          <a:xfrm>
            <a:off x="0" y="6444218"/>
            <a:ext cx="33805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0704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5</TotalTime>
  <Words>38</Words>
  <Application>Microsoft Office PowerPoint</Application>
  <PresentationFormat>A4 210 x 297 mm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61</cp:revision>
  <dcterms:created xsi:type="dcterms:W3CDTF">2021-01-02T08:05:56Z</dcterms:created>
  <dcterms:modified xsi:type="dcterms:W3CDTF">2021-05-23T14:24:45Z</dcterms:modified>
</cp:coreProperties>
</file>